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3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92565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68132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94363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35179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69269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074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36121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751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19677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89381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25859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91755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ovéPole 6"/>
          <p:cNvSpPr txBox="1"/>
          <p:nvPr/>
        </p:nvSpPr>
        <p:spPr>
          <a:xfrm>
            <a:off x="838276" y="5492454"/>
            <a:ext cx="8403001" cy="8867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BABA perception affects gene expression of certain protein kinase families. 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of protein kinase genes (A) and proteins (</a:t>
            </a:r>
            <a:r>
              <a:rPr lang="cs-CZ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exhibiting differential expression following BABA treatment. (</a:t>
            </a:r>
            <a:r>
              <a:rPr lang="cs-CZ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The number of induced Receptor-Like Kinase/Pelle (RLK-Pelle) family t</a:t>
            </a:r>
            <a:r>
              <a:rPr lang="cs-CZ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nscripts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Cut-offs of a ≥2-fold difference in expression and P ≤ 0.01 (for genes) or P ≤ 0.05 (for proteins) were applied. Asterisks indicate significantly enriched families/members identified by the chi-squared test.</a:t>
            </a:r>
          </a:p>
          <a:p>
            <a:pPr algn="just"/>
            <a:endParaRPr lang="en-US" sz="762" dirty="0"/>
          </a:p>
        </p:txBody>
      </p:sp>
      <p:grpSp>
        <p:nvGrpSpPr>
          <p:cNvPr id="6" name="Skupina 5">
            <a:extLst>
              <a:ext uri="{FF2B5EF4-FFF2-40B4-BE49-F238E27FC236}">
                <a16:creationId xmlns:a16="http://schemas.microsoft.com/office/drawing/2014/main" id="{059D00D7-32D2-1D40-ED96-EA1B9220D7A4}"/>
              </a:ext>
            </a:extLst>
          </p:cNvPr>
          <p:cNvGrpSpPr/>
          <p:nvPr/>
        </p:nvGrpSpPr>
        <p:grpSpPr>
          <a:xfrm>
            <a:off x="740998" y="256798"/>
            <a:ext cx="8500279" cy="4835752"/>
            <a:chOff x="740998" y="256798"/>
            <a:chExt cx="8500279" cy="4835752"/>
          </a:xfrm>
        </p:grpSpPr>
        <p:pic>
          <p:nvPicPr>
            <p:cNvPr id="2" name="Obrázek 1">
              <a:extLst>
                <a:ext uri="{FF2B5EF4-FFF2-40B4-BE49-F238E27FC236}">
                  <a16:creationId xmlns:a16="http://schemas.microsoft.com/office/drawing/2014/main" id="{999DF931-D0D3-78E7-3F7C-A4C88538FF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0998" y="256798"/>
              <a:ext cx="8500279" cy="483575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" name="TextovéPole 2">
              <a:extLst>
                <a:ext uri="{FF2B5EF4-FFF2-40B4-BE49-F238E27FC236}">
                  <a16:creationId xmlns:a16="http://schemas.microsoft.com/office/drawing/2014/main" id="{6CB44D1C-F659-A682-F0D7-2F5812558B3C}"/>
                </a:ext>
              </a:extLst>
            </p:cNvPr>
            <p:cNvSpPr txBox="1"/>
            <p:nvPr/>
          </p:nvSpPr>
          <p:spPr>
            <a:xfrm>
              <a:off x="798148" y="324939"/>
              <a:ext cx="29367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4" name="TextovéPole 3">
              <a:extLst>
                <a:ext uri="{FF2B5EF4-FFF2-40B4-BE49-F238E27FC236}">
                  <a16:creationId xmlns:a16="http://schemas.microsoft.com/office/drawing/2014/main" id="{D6D217AB-D610-8851-8009-58294117A917}"/>
                </a:ext>
              </a:extLst>
            </p:cNvPr>
            <p:cNvSpPr txBox="1"/>
            <p:nvPr/>
          </p:nvSpPr>
          <p:spPr>
            <a:xfrm>
              <a:off x="5122498" y="324939"/>
              <a:ext cx="28565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5" name="TextovéPole 4">
              <a:extLst>
                <a:ext uri="{FF2B5EF4-FFF2-40B4-BE49-F238E27FC236}">
                  <a16:creationId xmlns:a16="http://schemas.microsoft.com/office/drawing/2014/main" id="{29ADD6D4-8217-BFCD-01C8-D631FFA7DE0B}"/>
                </a:ext>
              </a:extLst>
            </p:cNvPr>
            <p:cNvSpPr txBox="1"/>
            <p:nvPr/>
          </p:nvSpPr>
          <p:spPr>
            <a:xfrm>
              <a:off x="798148" y="2448592"/>
              <a:ext cx="27924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180845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6</TotalTime>
  <Words>96</Words>
  <Application>Microsoft Office PowerPoint</Application>
  <PresentationFormat>A4 (210 ×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ochik</dc:creator>
  <cp:lastModifiedBy>Jan Lochman</cp:lastModifiedBy>
  <cp:revision>19</cp:revision>
  <dcterms:created xsi:type="dcterms:W3CDTF">2018-04-26T14:11:40Z</dcterms:created>
  <dcterms:modified xsi:type="dcterms:W3CDTF">2023-03-02T07:55:01Z</dcterms:modified>
</cp:coreProperties>
</file>